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4" autoAdjust="0"/>
    <p:restoredTop sz="94660"/>
  </p:normalViewPr>
  <p:slideViewPr>
    <p:cSldViewPr snapToGrid="0">
      <p:cViewPr varScale="1">
        <p:scale>
          <a:sx n="76" d="100"/>
          <a:sy n="76" d="100"/>
        </p:scale>
        <p:origin x="233" y="4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52673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399734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649130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53759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29721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95888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327690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918679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74051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428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5313608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9467DF-794B-4D73-B6CB-FFC561795D25}" type="datetimeFigureOut">
              <a:rPr lang="en-US" smtClean="0"/>
              <a:t>10/15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B7E8994-0C32-4529-89BD-5AA29656841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782884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Group 33"/>
          <p:cNvGrpSpPr/>
          <p:nvPr/>
        </p:nvGrpSpPr>
        <p:grpSpPr>
          <a:xfrm>
            <a:off x="3258636" y="117230"/>
            <a:ext cx="5361522" cy="6588369"/>
            <a:chOff x="3258636" y="117230"/>
            <a:chExt cx="5361522" cy="6588369"/>
          </a:xfrm>
        </p:grpSpPr>
        <p:pic>
          <p:nvPicPr>
            <p:cNvPr id="2" name="Picture 1"/>
            <p:cNvPicPr>
              <a:picLocks noChangeAspect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258636" y="117230"/>
              <a:ext cx="5361522" cy="6588369"/>
            </a:xfrm>
            <a:prstGeom prst="rect">
              <a:avLst/>
            </a:prstGeom>
          </p:spPr>
        </p:pic>
        <p:sp>
          <p:nvSpPr>
            <p:cNvPr id="3" name="TextBox 2"/>
            <p:cNvSpPr txBox="1"/>
            <p:nvPr/>
          </p:nvSpPr>
          <p:spPr>
            <a:xfrm>
              <a:off x="4525108" y="996462"/>
              <a:ext cx="4571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endParaRPr lang="en-US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" name="TextBox 3"/>
            <p:cNvSpPr txBox="1"/>
            <p:nvPr/>
          </p:nvSpPr>
          <p:spPr>
            <a:xfrm>
              <a:off x="4570827" y="781018"/>
              <a:ext cx="5483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11</a:t>
              </a:r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6786488" y="781018"/>
              <a:ext cx="5483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11</a:t>
              </a:r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4575838" y="1894749"/>
              <a:ext cx="548355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11</a:t>
              </a: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6878572" y="1894749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31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570827" y="3649508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31</a:t>
              </a: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6878571" y="3649507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33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133669" y="5442380"/>
              <a:ext cx="47481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5</a:t>
              </a: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5222661" y="5442379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29</a:t>
              </a:r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6229592" y="5442378"/>
              <a:ext cx="55976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>
                  <a:latin typeface="Arial" panose="020B0604020202020204" pitchFamily="34" charset="0"/>
                  <a:cs typeface="Arial" panose="020B0604020202020204" pitchFamily="34" charset="0"/>
                </a:rPr>
                <a:t>YP29</a:t>
              </a:r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7713784" y="300410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15" name="Straight Connector 14"/>
            <p:cNvCxnSpPr/>
            <p:nvPr/>
          </p:nvCxnSpPr>
          <p:spPr>
            <a:xfrm>
              <a:off x="3780020" y="5719377"/>
              <a:ext cx="1339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" name="Straight Connector 17"/>
            <p:cNvCxnSpPr/>
            <p:nvPr/>
          </p:nvCxnSpPr>
          <p:spPr>
            <a:xfrm>
              <a:off x="5159741" y="5719377"/>
              <a:ext cx="6461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0" name="Straight Connector 19"/>
            <p:cNvCxnSpPr/>
            <p:nvPr/>
          </p:nvCxnSpPr>
          <p:spPr>
            <a:xfrm>
              <a:off x="6176049" y="5719377"/>
              <a:ext cx="646135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1" name="TextBox 20"/>
            <p:cNvSpPr txBox="1"/>
            <p:nvPr/>
          </p:nvSpPr>
          <p:spPr>
            <a:xfrm>
              <a:off x="3748310" y="312133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7348015" y="2286291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3859235" y="4063381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4203781" y="4056770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4757574" y="4073731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5128378" y="4095804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4203781" y="6034306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5135423" y="6002427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5667537" y="6030985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6603356" y="5996376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  <p:cxnSp>
          <p:nvCxnSpPr>
            <p:cNvPr id="31" name="Straight Connector 30"/>
            <p:cNvCxnSpPr/>
            <p:nvPr/>
          </p:nvCxnSpPr>
          <p:spPr>
            <a:xfrm>
              <a:off x="6905976" y="5719377"/>
              <a:ext cx="1339162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2" name="TextBox 31"/>
            <p:cNvSpPr txBox="1"/>
            <p:nvPr/>
          </p:nvSpPr>
          <p:spPr>
            <a:xfrm>
              <a:off x="7213077" y="5454793"/>
              <a:ext cx="35618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  <a:endParaRPr lang="en-US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7318460" y="5984654"/>
              <a:ext cx="274434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69D5AD8D-F616-4BCD-A69D-FAC432D0DA27}"/>
              </a:ext>
            </a:extLst>
          </p:cNvPr>
          <p:cNvSpPr txBox="1"/>
          <p:nvPr/>
        </p:nvSpPr>
        <p:spPr>
          <a:xfrm>
            <a:off x="9003324" y="1894749"/>
            <a:ext cx="2672862" cy="20313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Raw gel image of candidate clones digested with </a:t>
            </a:r>
            <a:r>
              <a:rPr lang="en-US" i="1" dirty="0" err="1"/>
              <a:t>Ava</a:t>
            </a:r>
            <a:r>
              <a:rPr lang="en-US" dirty="0" err="1"/>
              <a:t>II</a:t>
            </a:r>
            <a:r>
              <a:rPr lang="en-US" dirty="0"/>
              <a:t> at Step 7.</a:t>
            </a:r>
          </a:p>
          <a:p>
            <a:endParaRPr lang="en-US" dirty="0"/>
          </a:p>
          <a:p>
            <a:r>
              <a:rPr lang="en-US" dirty="0"/>
              <a:t>The clones labelled with * were advanced for sequencing. </a:t>
            </a:r>
          </a:p>
        </p:txBody>
      </p:sp>
    </p:spTree>
    <p:extLst>
      <p:ext uri="{BB962C8B-B14F-4D97-AF65-F5344CB8AC3E}">
        <p14:creationId xmlns:p14="http://schemas.microsoft.com/office/powerpoint/2010/main" val="425542777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2</TotalTime>
  <Words>45</Words>
  <Application>Microsoft Office PowerPoint</Application>
  <PresentationFormat>Widescreen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oobc</dc:creator>
  <cp:lastModifiedBy>Hajime Sakai</cp:lastModifiedBy>
  <cp:revision>5</cp:revision>
  <dcterms:created xsi:type="dcterms:W3CDTF">2018-10-14T23:13:56Z</dcterms:created>
  <dcterms:modified xsi:type="dcterms:W3CDTF">2018-10-15T16:48:40Z</dcterms:modified>
</cp:coreProperties>
</file>